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60" r:id="rId5"/>
    <p:sldId id="259" r:id="rId6"/>
    <p:sldId id="261" r:id="rId7"/>
    <p:sldId id="262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oshida Shun" initials="YS" lastIdx="1" clrIdx="0">
    <p:extLst>
      <p:ext uri="{19B8F6BF-5375-455C-9EA6-DF929625EA0E}">
        <p15:presenceInfo xmlns:p15="http://schemas.microsoft.com/office/powerpoint/2012/main" userId="5de8db52ba4204f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1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3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0963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5856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095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4927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01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682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4701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4727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4232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81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2639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9321E8-D6AC-40A7-AC4A-6BED8254D3BA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170F2E-AA85-47CF-8B61-38F2175781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8951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g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1.jpg"/><Relationship Id="rId7" Type="http://schemas.openxmlformats.org/officeDocument/2006/relationships/image" Target="../media/image14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g"/><Relationship Id="rId5" Type="http://schemas.microsoft.com/office/2007/relationships/hdphoto" Target="../media/hdphoto2.wdp"/><Relationship Id="rId4" Type="http://schemas.openxmlformats.org/officeDocument/2006/relationships/image" Target="../media/image12.png"/><Relationship Id="rId9" Type="http://schemas.openxmlformats.org/officeDocument/2006/relationships/image" Target="../media/image16.jp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jpg"/><Relationship Id="rId4" Type="http://schemas.openxmlformats.org/officeDocument/2006/relationships/image" Target="../media/image18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g"/><Relationship Id="rId5" Type="http://schemas.microsoft.com/office/2007/relationships/hdphoto" Target="../media/hdphoto4.wdp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g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99934E64-0FF9-27DE-F2E2-3BACB172E15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96" t="57239" r="29794" b="18944"/>
          <a:stretch/>
        </p:blipFill>
        <p:spPr>
          <a:xfrm>
            <a:off x="2144708" y="3722914"/>
            <a:ext cx="2889725" cy="2037805"/>
          </a:xfrm>
          <a:prstGeom prst="rect">
            <a:avLst/>
          </a:prstGeom>
          <a:ln w="19050">
            <a:noFill/>
          </a:ln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9190158B-FB3D-EBD5-C518-59CC521A00B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26" t="54935" r="27976" b="21255"/>
          <a:stretch/>
        </p:blipFill>
        <p:spPr>
          <a:xfrm>
            <a:off x="2144709" y="1005840"/>
            <a:ext cx="2889725" cy="2037806"/>
          </a:xfrm>
          <a:prstGeom prst="rect">
            <a:avLst/>
          </a:prstGeom>
          <a:ln w="19050">
            <a:noFill/>
          </a:ln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3F030EE-D672-B423-2854-E292F74AE22E}"/>
              </a:ext>
            </a:extLst>
          </p:cNvPr>
          <p:cNvSpPr txBox="1"/>
          <p:nvPr/>
        </p:nvSpPr>
        <p:spPr>
          <a:xfrm>
            <a:off x="0" y="15027"/>
            <a:ext cx="1624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1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BD986246-A6E4-D715-6C75-D4671C01755E}"/>
              </a:ext>
            </a:extLst>
          </p:cNvPr>
          <p:cNvSpPr/>
          <p:nvPr/>
        </p:nvSpPr>
        <p:spPr>
          <a:xfrm>
            <a:off x="2590572" y="1361519"/>
            <a:ext cx="1998000" cy="1026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335D4D4-F2EE-CE23-C31F-87876000E237}"/>
              </a:ext>
            </a:extLst>
          </p:cNvPr>
          <p:cNvSpPr txBox="1"/>
          <p:nvPr/>
        </p:nvSpPr>
        <p:spPr>
          <a:xfrm>
            <a:off x="733535" y="1734165"/>
            <a:ext cx="11285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GFP</a:t>
            </a:r>
          </a:p>
          <a:p>
            <a:r>
              <a:rPr kumimoji="1" lang="en-US" altLang="ja-JP" sz="1600" dirty="0"/>
              <a:t>(DNAJC13)</a:t>
            </a: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C8F5ED13-93B3-4100-F3C3-1590D86F6922}"/>
              </a:ext>
            </a:extLst>
          </p:cNvPr>
          <p:cNvSpPr/>
          <p:nvPr/>
        </p:nvSpPr>
        <p:spPr>
          <a:xfrm>
            <a:off x="2673723" y="4127719"/>
            <a:ext cx="1998000" cy="1944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CF23B7E-ECAA-0E4C-AC48-41B0E62C5B46}"/>
              </a:ext>
            </a:extLst>
          </p:cNvPr>
          <p:cNvSpPr txBox="1"/>
          <p:nvPr/>
        </p:nvSpPr>
        <p:spPr>
          <a:xfrm>
            <a:off x="653481" y="4055642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M6PR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9D5E7DD-36F8-D271-97DC-A62F5A545BB6}"/>
              </a:ext>
            </a:extLst>
          </p:cNvPr>
          <p:cNvSpPr txBox="1"/>
          <p:nvPr/>
        </p:nvSpPr>
        <p:spPr>
          <a:xfrm>
            <a:off x="169452" y="384359"/>
            <a:ext cx="3383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9652776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DAB4783-6BF3-B4B7-616F-66EF72FDA8D2}"/>
              </a:ext>
            </a:extLst>
          </p:cNvPr>
          <p:cNvSpPr txBox="1"/>
          <p:nvPr/>
        </p:nvSpPr>
        <p:spPr>
          <a:xfrm>
            <a:off x="0" y="15027"/>
            <a:ext cx="1624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2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2E97214-7938-CBC3-7D96-CDFC63D5A200}"/>
              </a:ext>
            </a:extLst>
          </p:cNvPr>
          <p:cNvSpPr txBox="1"/>
          <p:nvPr/>
        </p:nvSpPr>
        <p:spPr>
          <a:xfrm>
            <a:off x="397659" y="2676741"/>
            <a:ext cx="1626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lag (SNX-1)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63094DB-B4EC-B0CB-3DE7-AFAE01702DE0}"/>
              </a:ext>
            </a:extLst>
          </p:cNvPr>
          <p:cNvSpPr txBox="1"/>
          <p:nvPr/>
        </p:nvSpPr>
        <p:spPr>
          <a:xfrm>
            <a:off x="292239" y="1093024"/>
            <a:ext cx="1624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GFP (DNAJC13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DE2475B-BD8B-DF60-9EA9-F93E3A7DA919}"/>
              </a:ext>
            </a:extLst>
          </p:cNvPr>
          <p:cNvSpPr txBox="1"/>
          <p:nvPr/>
        </p:nvSpPr>
        <p:spPr>
          <a:xfrm>
            <a:off x="812192" y="5423281"/>
            <a:ext cx="1626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Hsc70</a:t>
            </a: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0BB48459-35FE-1615-EB85-FF372DE66D9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12" t="61074" r="22048" b="28622"/>
          <a:stretch/>
        </p:blipFill>
        <p:spPr>
          <a:xfrm>
            <a:off x="2024007" y="687057"/>
            <a:ext cx="3452818" cy="1001266"/>
          </a:xfrm>
          <a:prstGeom prst="rect">
            <a:avLst/>
          </a:prstGeom>
        </p:spPr>
      </p:pic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FA45E5B7-0591-DF35-9F8F-ACF57A6734F3}"/>
              </a:ext>
            </a:extLst>
          </p:cNvPr>
          <p:cNvSpPr/>
          <p:nvPr/>
        </p:nvSpPr>
        <p:spPr>
          <a:xfrm>
            <a:off x="2418600" y="1187690"/>
            <a:ext cx="1620000" cy="180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9CC2CC56-C412-121D-B9D2-845D1F59EA4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21" t="54776" r="25892" b="19443"/>
          <a:stretch/>
        </p:blipFill>
        <p:spPr>
          <a:xfrm>
            <a:off x="1916623" y="1698584"/>
            <a:ext cx="3560202" cy="2694978"/>
          </a:xfrm>
          <a:prstGeom prst="rect">
            <a:avLst/>
          </a:prstGeom>
        </p:spPr>
      </p:pic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81AA09C6-A59F-C140-0FF1-64BAD9899C8B}"/>
              </a:ext>
            </a:extLst>
          </p:cNvPr>
          <p:cNvSpPr/>
          <p:nvPr/>
        </p:nvSpPr>
        <p:spPr>
          <a:xfrm>
            <a:off x="2578107" y="2470552"/>
            <a:ext cx="1620000" cy="180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126E7B82-E27D-AAE5-2C91-5322597A212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91" t="64710" r="28196" b="14380"/>
          <a:stretch/>
        </p:blipFill>
        <p:spPr>
          <a:xfrm>
            <a:off x="2024007" y="4620538"/>
            <a:ext cx="2862072" cy="2036109"/>
          </a:xfrm>
          <a:prstGeom prst="rect">
            <a:avLst/>
          </a:prstGeom>
        </p:spPr>
      </p:pic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396A763A-CCF8-0592-F3BE-EC94746D0D56}"/>
              </a:ext>
            </a:extLst>
          </p:cNvPr>
          <p:cNvSpPr/>
          <p:nvPr/>
        </p:nvSpPr>
        <p:spPr>
          <a:xfrm>
            <a:off x="2316184" y="4951007"/>
            <a:ext cx="1620000" cy="180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E6E7553-7E9B-6D21-8ED6-69D7B3AC7590}"/>
              </a:ext>
            </a:extLst>
          </p:cNvPr>
          <p:cNvSpPr txBox="1"/>
          <p:nvPr/>
        </p:nvSpPr>
        <p:spPr>
          <a:xfrm>
            <a:off x="169452" y="384359"/>
            <a:ext cx="3383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977982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9790AD5-C4DE-9F6D-3355-9F7B13904EFC}"/>
              </a:ext>
            </a:extLst>
          </p:cNvPr>
          <p:cNvSpPr txBox="1"/>
          <p:nvPr/>
        </p:nvSpPr>
        <p:spPr>
          <a:xfrm>
            <a:off x="434292" y="1216327"/>
            <a:ext cx="16243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IB: GFP</a:t>
            </a:r>
          </a:p>
          <a:p>
            <a:r>
              <a:rPr kumimoji="1" lang="en-US" altLang="ja-JP" dirty="0"/>
              <a:t>(DNAJC13)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E89028CC-9284-3154-6B62-298C5DBB3C7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5000"/>
                    </a14:imgEffect>
                    <a14:imgEffect>
                      <a14:brightnessContrast bright="-1000" contrast="-3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860" t="58874" r="25582" b="17767"/>
          <a:stretch/>
        </p:blipFill>
        <p:spPr>
          <a:xfrm>
            <a:off x="1624383" y="1925834"/>
            <a:ext cx="3669791" cy="2437307"/>
          </a:xfrm>
          <a:prstGeom prst="rect">
            <a:avLst/>
          </a:prstGeom>
          <a:ln w="19050">
            <a:noFill/>
          </a:ln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DE5CA70C-8FDF-C21F-AAE1-5AC42B47450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65" t="64578" r="31414" b="27725"/>
          <a:stretch/>
        </p:blipFill>
        <p:spPr>
          <a:xfrm>
            <a:off x="1819219" y="1027871"/>
            <a:ext cx="3219562" cy="821849"/>
          </a:xfrm>
          <a:prstGeom prst="rect">
            <a:avLst/>
          </a:prstGeom>
          <a:noFill/>
          <a:ln w="19050">
            <a:noFill/>
          </a:ln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1F22FA-1C3E-74BF-8436-931AEF222CAB}"/>
              </a:ext>
            </a:extLst>
          </p:cNvPr>
          <p:cNvSpPr txBox="1"/>
          <p:nvPr/>
        </p:nvSpPr>
        <p:spPr>
          <a:xfrm>
            <a:off x="487537" y="2690824"/>
            <a:ext cx="10026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IB: flag</a:t>
            </a:r>
          </a:p>
          <a:p>
            <a:r>
              <a:rPr kumimoji="1" lang="en-US" altLang="ja-JP" dirty="0"/>
              <a:t>(SNX-1)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8F77018-AD66-A0A1-A709-84DD4C781B4B}"/>
              </a:ext>
            </a:extLst>
          </p:cNvPr>
          <p:cNvSpPr txBox="1"/>
          <p:nvPr/>
        </p:nvSpPr>
        <p:spPr>
          <a:xfrm>
            <a:off x="885344" y="5254584"/>
            <a:ext cx="12305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IB: GFP</a:t>
            </a:r>
          </a:p>
          <a:p>
            <a:r>
              <a:rPr kumimoji="1" lang="en-US" altLang="ja-JP" dirty="0"/>
              <a:t>(DNAJC13)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FC018FB-0217-485C-4294-433BE5AF7EA5}"/>
              </a:ext>
            </a:extLst>
          </p:cNvPr>
          <p:cNvSpPr txBox="1"/>
          <p:nvPr/>
        </p:nvSpPr>
        <p:spPr>
          <a:xfrm>
            <a:off x="933278" y="8107775"/>
            <a:ext cx="10026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IB: flag</a:t>
            </a:r>
          </a:p>
          <a:p>
            <a:r>
              <a:rPr kumimoji="1" lang="en-US" altLang="ja-JP" dirty="0"/>
              <a:t>(SNX-1)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01CE7F7-D480-95E2-9FB9-0A86181DD8FF}"/>
              </a:ext>
            </a:extLst>
          </p:cNvPr>
          <p:cNvSpPr txBox="1"/>
          <p:nvPr/>
        </p:nvSpPr>
        <p:spPr>
          <a:xfrm>
            <a:off x="169452" y="384359"/>
            <a:ext cx="3383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A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52EA662-5A6F-3228-9023-04DBBFCEC868}"/>
              </a:ext>
            </a:extLst>
          </p:cNvPr>
          <p:cNvSpPr txBox="1"/>
          <p:nvPr/>
        </p:nvSpPr>
        <p:spPr>
          <a:xfrm>
            <a:off x="169452" y="5058679"/>
            <a:ext cx="3383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D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C263DC0-FEAB-FCB5-3D16-C2A4E0958854}"/>
              </a:ext>
            </a:extLst>
          </p:cNvPr>
          <p:cNvSpPr txBox="1"/>
          <p:nvPr/>
        </p:nvSpPr>
        <p:spPr>
          <a:xfrm>
            <a:off x="0" y="15027"/>
            <a:ext cx="1624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3</a:t>
            </a: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2689E84E-834F-B1C8-21F4-923BB3B3E428}"/>
              </a:ext>
            </a:extLst>
          </p:cNvPr>
          <p:cNvSpPr/>
          <p:nvPr/>
        </p:nvSpPr>
        <p:spPr>
          <a:xfrm>
            <a:off x="2435131" y="1395493"/>
            <a:ext cx="2206800" cy="28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5E3D657F-BB7B-19B4-54F4-1BDAF34E27C6}"/>
              </a:ext>
            </a:extLst>
          </p:cNvPr>
          <p:cNvSpPr/>
          <p:nvPr/>
        </p:nvSpPr>
        <p:spPr>
          <a:xfrm>
            <a:off x="2358730" y="2571519"/>
            <a:ext cx="2206800" cy="28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542A15B4-EB7F-70AB-29FE-16C7A49D4C1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24" t="55857" r="30748" b="17142"/>
          <a:stretch/>
        </p:blipFill>
        <p:spPr>
          <a:xfrm>
            <a:off x="1935958" y="4403212"/>
            <a:ext cx="3192946" cy="2761688"/>
          </a:xfrm>
          <a:prstGeom prst="rect">
            <a:avLst/>
          </a:prstGeom>
        </p:spPr>
      </p:pic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73287538-F69D-2582-1A08-1C4626144E87}"/>
              </a:ext>
            </a:extLst>
          </p:cNvPr>
          <p:cNvSpPr/>
          <p:nvPr/>
        </p:nvSpPr>
        <p:spPr>
          <a:xfrm>
            <a:off x="2584283" y="4826635"/>
            <a:ext cx="1620000" cy="28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3D7C3CC2-8E70-B74F-D813-95274546A02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10" t="59073" r="29406" b="13801"/>
          <a:stretch/>
        </p:blipFill>
        <p:spPr>
          <a:xfrm>
            <a:off x="2058676" y="7032064"/>
            <a:ext cx="3192946" cy="2797755"/>
          </a:xfrm>
          <a:prstGeom prst="rect">
            <a:avLst/>
          </a:prstGeom>
        </p:spPr>
      </p:pic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F95517F0-C5DA-EE87-7677-8808B91531D2}"/>
              </a:ext>
            </a:extLst>
          </p:cNvPr>
          <p:cNvSpPr/>
          <p:nvPr/>
        </p:nvSpPr>
        <p:spPr>
          <a:xfrm>
            <a:off x="2645442" y="7690612"/>
            <a:ext cx="1620000" cy="288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</p:spTree>
    <p:extLst>
      <p:ext uri="{BB962C8B-B14F-4D97-AF65-F5344CB8AC3E}">
        <p14:creationId xmlns:p14="http://schemas.microsoft.com/office/powerpoint/2010/main" val="1436915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図 33">
            <a:extLst>
              <a:ext uri="{FF2B5EF4-FFF2-40B4-BE49-F238E27FC236}">
                <a16:creationId xmlns:a16="http://schemas.microsoft.com/office/drawing/2014/main" id="{8DABA2D0-9579-8D9B-A0D8-491F76AB94B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34" t="64671" r="30184" b="21037"/>
          <a:stretch/>
        </p:blipFill>
        <p:spPr>
          <a:xfrm>
            <a:off x="4313500" y="1464194"/>
            <a:ext cx="2348511" cy="1084016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4CE21AF5-E410-575B-8651-FD02FACE51E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09" t="67133" r="26188" b="23642"/>
          <a:stretch/>
        </p:blipFill>
        <p:spPr>
          <a:xfrm>
            <a:off x="885131" y="1662501"/>
            <a:ext cx="2527245" cy="699673"/>
          </a:xfrm>
          <a:prstGeom prst="rect">
            <a:avLst/>
          </a:prstGeom>
          <a:ln w="19050">
            <a:noFill/>
          </a:ln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F93D133-A15A-180B-FB60-FF2EE80A62D4}"/>
              </a:ext>
            </a:extLst>
          </p:cNvPr>
          <p:cNvSpPr txBox="1"/>
          <p:nvPr/>
        </p:nvSpPr>
        <p:spPr>
          <a:xfrm>
            <a:off x="0" y="58917"/>
            <a:ext cx="1624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4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AB5E3BD-AA2F-558A-2E17-A110A823FB9B}"/>
              </a:ext>
            </a:extLst>
          </p:cNvPr>
          <p:cNvSpPr txBox="1"/>
          <p:nvPr/>
        </p:nvSpPr>
        <p:spPr>
          <a:xfrm>
            <a:off x="222520" y="4021997"/>
            <a:ext cx="3561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D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9F8CFA8-7AB0-576D-25D5-BC93250FAC9B}"/>
              </a:ext>
            </a:extLst>
          </p:cNvPr>
          <p:cNvSpPr txBox="1"/>
          <p:nvPr/>
        </p:nvSpPr>
        <p:spPr>
          <a:xfrm>
            <a:off x="3524716" y="6798307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</a:t>
            </a:r>
            <a:r>
              <a:rPr kumimoji="1" lang="en-US" altLang="ja-JP" sz="1600" dirty="0" err="1"/>
              <a:t>aS</a:t>
            </a:r>
            <a:endParaRPr kumimoji="1" lang="en-US" altLang="ja-JP" sz="16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52295B0-1907-95B2-E037-1617EC5258B3}"/>
              </a:ext>
            </a:extLst>
          </p:cNvPr>
          <p:cNvSpPr txBox="1"/>
          <p:nvPr/>
        </p:nvSpPr>
        <p:spPr>
          <a:xfrm>
            <a:off x="222520" y="8581980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Rab5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B90B80D-7209-DB72-3E95-0323AEEB1E0E}"/>
              </a:ext>
            </a:extLst>
          </p:cNvPr>
          <p:cNvSpPr txBox="1"/>
          <p:nvPr/>
        </p:nvSpPr>
        <p:spPr>
          <a:xfrm>
            <a:off x="222520" y="4506803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SNX-1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1B3E47D-41F2-B853-0B0E-8487189AB6B6}"/>
              </a:ext>
            </a:extLst>
          </p:cNvPr>
          <p:cNvSpPr txBox="1"/>
          <p:nvPr/>
        </p:nvSpPr>
        <p:spPr>
          <a:xfrm>
            <a:off x="3545128" y="4865153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VS35</a:t>
            </a:r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D0248369-2AD9-74D8-CB7C-AA51D70B0228}"/>
              </a:ext>
            </a:extLst>
          </p:cNvPr>
          <p:cNvGrpSpPr>
            <a:grpSpLocks noChangeAspect="1"/>
          </p:cNvGrpSpPr>
          <p:nvPr/>
        </p:nvGrpSpPr>
        <p:grpSpPr>
          <a:xfrm>
            <a:off x="1351036" y="4558666"/>
            <a:ext cx="2273311" cy="1156197"/>
            <a:chOff x="475630" y="1212301"/>
            <a:chExt cx="6365881" cy="3237662"/>
          </a:xfrm>
        </p:grpSpPr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9E210594-0E7F-3637-BD26-4420D8E77F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000"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70" t="58901" r="27709" b="23073"/>
            <a:stretch/>
          </p:blipFill>
          <p:spPr>
            <a:xfrm>
              <a:off x="475630" y="1212301"/>
              <a:ext cx="6365881" cy="3237662"/>
            </a:xfrm>
            <a:prstGeom prst="rect">
              <a:avLst/>
            </a:prstGeom>
          </p:spPr>
        </p:pic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EB9A35CB-3234-63A0-366D-921AFA80FE54}"/>
                </a:ext>
              </a:extLst>
            </p:cNvPr>
            <p:cNvSpPr/>
            <p:nvPr/>
          </p:nvSpPr>
          <p:spPr>
            <a:xfrm rot="239994">
              <a:off x="1914562" y="3238972"/>
              <a:ext cx="2221200" cy="2592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noFill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FA6FCEEA-872F-DACD-2712-48EF8FA62570}"/>
              </a:ext>
            </a:extLst>
          </p:cNvPr>
          <p:cNvGrpSpPr>
            <a:grpSpLocks noChangeAspect="1"/>
          </p:cNvGrpSpPr>
          <p:nvPr/>
        </p:nvGrpSpPr>
        <p:grpSpPr>
          <a:xfrm>
            <a:off x="1549533" y="5942155"/>
            <a:ext cx="2027849" cy="1544779"/>
            <a:chOff x="1055862" y="4505732"/>
            <a:chExt cx="4746275" cy="3615627"/>
          </a:xfrm>
        </p:grpSpPr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39800B5C-0AA2-0B25-4CD2-A383AF0938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95" t="63429" r="35297" b="14811"/>
            <a:stretch/>
          </p:blipFill>
          <p:spPr>
            <a:xfrm>
              <a:off x="1055862" y="4505732"/>
              <a:ext cx="4746275" cy="3615627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1C0CD952-2FD3-49FE-9602-FF69112D08F8}"/>
                </a:ext>
              </a:extLst>
            </p:cNvPr>
            <p:cNvSpPr/>
            <p:nvPr/>
          </p:nvSpPr>
          <p:spPr>
            <a:xfrm>
              <a:off x="1929003" y="5983797"/>
              <a:ext cx="2221200" cy="2592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noFill/>
              </a:endParaRPr>
            </a:p>
          </p:txBody>
        </p:sp>
      </p:grp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FA74104-6DE5-5CBE-DFAB-2DAF629B7A5F}"/>
              </a:ext>
            </a:extLst>
          </p:cNvPr>
          <p:cNvSpPr txBox="1"/>
          <p:nvPr/>
        </p:nvSpPr>
        <p:spPr>
          <a:xfrm>
            <a:off x="179904" y="6629030"/>
            <a:ext cx="13276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β-tubulin</a:t>
            </a:r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9903D4F1-60EA-97D0-5A8E-CC51AADDC16F}"/>
              </a:ext>
            </a:extLst>
          </p:cNvPr>
          <p:cNvGrpSpPr>
            <a:grpSpLocks noChangeAspect="1"/>
          </p:cNvGrpSpPr>
          <p:nvPr/>
        </p:nvGrpSpPr>
        <p:grpSpPr>
          <a:xfrm>
            <a:off x="1426801" y="7615784"/>
            <a:ext cx="2150581" cy="2025238"/>
            <a:chOff x="275109" y="4904473"/>
            <a:chExt cx="4602614" cy="4334359"/>
          </a:xfrm>
        </p:grpSpPr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D746E4D4-0D25-2F07-523E-18674D2E0F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92" t="52982" r="33293" b="20474"/>
            <a:stretch/>
          </p:blipFill>
          <p:spPr>
            <a:xfrm>
              <a:off x="275109" y="4904473"/>
              <a:ext cx="4602614" cy="4334359"/>
            </a:xfrm>
            <a:prstGeom prst="rect">
              <a:avLst/>
            </a:prstGeom>
          </p:spPr>
        </p:pic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7B92EFBB-092A-0B1E-1F23-D781E4DD66AB}"/>
                </a:ext>
              </a:extLst>
            </p:cNvPr>
            <p:cNvSpPr/>
            <p:nvPr/>
          </p:nvSpPr>
          <p:spPr>
            <a:xfrm rot="263037">
              <a:off x="1035755" y="7101683"/>
              <a:ext cx="2221200" cy="2592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noFill/>
              </a:endParaRPr>
            </a:p>
          </p:txBody>
        </p: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162C2396-BE28-7C38-E6BB-F8F5C08D891E}"/>
              </a:ext>
            </a:extLst>
          </p:cNvPr>
          <p:cNvGrpSpPr>
            <a:grpSpLocks noChangeAspect="1"/>
          </p:cNvGrpSpPr>
          <p:nvPr/>
        </p:nvGrpSpPr>
        <p:grpSpPr>
          <a:xfrm>
            <a:off x="4618368" y="4315777"/>
            <a:ext cx="2150581" cy="1437306"/>
            <a:chOff x="670560" y="6500219"/>
            <a:chExt cx="5376671" cy="3593411"/>
          </a:xfrm>
        </p:grpSpPr>
        <p:pic>
          <p:nvPicPr>
            <p:cNvPr id="29" name="図 28">
              <a:extLst>
                <a:ext uri="{FF2B5EF4-FFF2-40B4-BE49-F238E27FC236}">
                  <a16:creationId xmlns:a16="http://schemas.microsoft.com/office/drawing/2014/main" id="{9FB93156-FFA6-A7D9-7540-1AB00E1199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87" t="60330" r="28594" b="18307"/>
            <a:stretch/>
          </p:blipFill>
          <p:spPr>
            <a:xfrm>
              <a:off x="670560" y="6500219"/>
              <a:ext cx="5376671" cy="3593411"/>
            </a:xfrm>
            <a:prstGeom prst="rect">
              <a:avLst/>
            </a:prstGeom>
            <a:noFill/>
            <a:ln w="12700">
              <a:noFill/>
            </a:ln>
          </p:spPr>
        </p:pic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FB13A172-97FE-D6BD-8359-966F7EC627E4}"/>
                </a:ext>
              </a:extLst>
            </p:cNvPr>
            <p:cNvSpPr/>
            <p:nvPr/>
          </p:nvSpPr>
          <p:spPr>
            <a:xfrm>
              <a:off x="1624384" y="7005457"/>
              <a:ext cx="2221200" cy="259200"/>
            </a:xfrm>
            <a:prstGeom prst="rect">
              <a:avLst/>
            </a:prstGeom>
            <a:noFill/>
            <a:ln w="1270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noFill/>
              </a:endParaRPr>
            </a:p>
          </p:txBody>
        </p:sp>
      </p:grp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F276751D-B599-182F-EFCA-45A2DA920C73}"/>
              </a:ext>
            </a:extLst>
          </p:cNvPr>
          <p:cNvGrpSpPr>
            <a:grpSpLocks noChangeAspect="1"/>
          </p:cNvGrpSpPr>
          <p:nvPr/>
        </p:nvGrpSpPr>
        <p:grpSpPr>
          <a:xfrm>
            <a:off x="4517136" y="6469865"/>
            <a:ext cx="2340864" cy="832410"/>
            <a:chOff x="4242816" y="5209288"/>
            <a:chExt cx="4962144" cy="1764535"/>
          </a:xfrm>
        </p:grpSpPr>
        <p:pic>
          <p:nvPicPr>
            <p:cNvPr id="31" name="図 30">
              <a:extLst>
                <a:ext uri="{FF2B5EF4-FFF2-40B4-BE49-F238E27FC236}">
                  <a16:creationId xmlns:a16="http://schemas.microsoft.com/office/drawing/2014/main" id="{6708ECFB-BC7A-5D37-5B5E-DEAF8523B2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095" t="66436" r="34323" b="23467"/>
            <a:stretch/>
          </p:blipFill>
          <p:spPr>
            <a:xfrm>
              <a:off x="4242816" y="5209288"/>
              <a:ext cx="4962144" cy="1764535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EE081B2D-AF93-B1B8-22FA-59D256AADCD6}"/>
                </a:ext>
              </a:extLst>
            </p:cNvPr>
            <p:cNvSpPr/>
            <p:nvPr/>
          </p:nvSpPr>
          <p:spPr>
            <a:xfrm>
              <a:off x="5197848" y="6150567"/>
              <a:ext cx="2221200" cy="2592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noFill/>
              </a:endParaRPr>
            </a:p>
          </p:txBody>
        </p:sp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7ECE94F-AE89-9BE1-5E3A-674A29F995D7}"/>
              </a:ext>
            </a:extLst>
          </p:cNvPr>
          <p:cNvSpPr txBox="1"/>
          <p:nvPr/>
        </p:nvSpPr>
        <p:spPr>
          <a:xfrm>
            <a:off x="179904" y="883029"/>
            <a:ext cx="3561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C</a:t>
            </a: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47319D71-8AC1-1332-7A6A-8E52453CEA73}"/>
              </a:ext>
            </a:extLst>
          </p:cNvPr>
          <p:cNvSpPr/>
          <p:nvPr/>
        </p:nvSpPr>
        <p:spPr>
          <a:xfrm>
            <a:off x="1631660" y="2006202"/>
            <a:ext cx="1080000" cy="1548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206A92C-46E9-F898-336A-CDF50FEE10BE}"/>
              </a:ext>
            </a:extLst>
          </p:cNvPr>
          <p:cNvSpPr txBox="1"/>
          <p:nvPr/>
        </p:nvSpPr>
        <p:spPr>
          <a:xfrm>
            <a:off x="179904" y="1777429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</a:t>
            </a:r>
            <a:r>
              <a:rPr kumimoji="1" lang="en-US" altLang="ja-JP" sz="1600" dirty="0" err="1"/>
              <a:t>aS</a:t>
            </a:r>
            <a:endParaRPr kumimoji="1" lang="en-US" altLang="ja-JP" sz="16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82C6381-0B3C-4E86-4508-04865CB6B992}"/>
              </a:ext>
            </a:extLst>
          </p:cNvPr>
          <p:cNvSpPr txBox="1"/>
          <p:nvPr/>
        </p:nvSpPr>
        <p:spPr>
          <a:xfrm>
            <a:off x="3366192" y="1758847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SNX-1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65C876D-7758-5A67-FAF5-CF2D6D4F220A}"/>
              </a:ext>
            </a:extLst>
          </p:cNvPr>
          <p:cNvSpPr/>
          <p:nvPr/>
        </p:nvSpPr>
        <p:spPr>
          <a:xfrm>
            <a:off x="4883367" y="1968456"/>
            <a:ext cx="1080000" cy="2268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</p:spTree>
    <p:extLst>
      <p:ext uri="{BB962C8B-B14F-4D97-AF65-F5344CB8AC3E}">
        <p14:creationId xmlns:p14="http://schemas.microsoft.com/office/powerpoint/2010/main" val="346102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A4E70E7-B38C-8D69-6D22-15B97FF4766C}"/>
              </a:ext>
            </a:extLst>
          </p:cNvPr>
          <p:cNvSpPr txBox="1"/>
          <p:nvPr/>
        </p:nvSpPr>
        <p:spPr>
          <a:xfrm>
            <a:off x="0" y="58917"/>
            <a:ext cx="1624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4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D283BF6-8391-424F-544D-4F5BB22F2189}"/>
              </a:ext>
            </a:extLst>
          </p:cNvPr>
          <p:cNvSpPr txBox="1"/>
          <p:nvPr/>
        </p:nvSpPr>
        <p:spPr>
          <a:xfrm>
            <a:off x="608844" y="1464008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VPS35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07BC7E-361D-B4B2-70C2-A4B59009D115}"/>
              </a:ext>
            </a:extLst>
          </p:cNvPr>
          <p:cNvSpPr txBox="1"/>
          <p:nvPr/>
        </p:nvSpPr>
        <p:spPr>
          <a:xfrm>
            <a:off x="463141" y="4300279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SNX-1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6615B77-F15B-ACF3-43A2-14BAB6180C8F}"/>
              </a:ext>
            </a:extLst>
          </p:cNvPr>
          <p:cNvSpPr txBox="1"/>
          <p:nvPr/>
        </p:nvSpPr>
        <p:spPr>
          <a:xfrm>
            <a:off x="761244" y="5655257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</a:t>
            </a:r>
            <a:r>
              <a:rPr kumimoji="1" lang="en-US" altLang="ja-JP" sz="1600" dirty="0" err="1"/>
              <a:t>aS</a:t>
            </a:r>
            <a:endParaRPr kumimoji="1" lang="en-US" altLang="ja-JP" sz="16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272FA7C-9DBF-5CA1-2586-0C568DBD685E}"/>
              </a:ext>
            </a:extLst>
          </p:cNvPr>
          <p:cNvSpPr txBox="1"/>
          <p:nvPr/>
        </p:nvSpPr>
        <p:spPr>
          <a:xfrm>
            <a:off x="80036" y="428249"/>
            <a:ext cx="3561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F</a:t>
            </a:r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7A72DA25-54DE-7208-793E-8A414F89068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0000" contrast="2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462" t="62094" r="25550" b="12673"/>
          <a:stretch/>
        </p:blipFill>
        <p:spPr>
          <a:xfrm>
            <a:off x="1816608" y="428249"/>
            <a:ext cx="3904666" cy="3034279"/>
          </a:xfrm>
          <a:prstGeom prst="rect">
            <a:avLst/>
          </a:prstGeom>
        </p:spPr>
      </p:pic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1588D466-C27D-800B-9F6F-CC74BE1ED4D9}"/>
              </a:ext>
            </a:extLst>
          </p:cNvPr>
          <p:cNvSpPr/>
          <p:nvPr/>
        </p:nvSpPr>
        <p:spPr>
          <a:xfrm rot="252520">
            <a:off x="2208892" y="1729379"/>
            <a:ext cx="2628000" cy="252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1B1500E0-B226-8B73-88E1-7D2B9D07E44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51" t="58351" r="26477" b="13690"/>
          <a:stretch/>
        </p:blipFill>
        <p:spPr>
          <a:xfrm>
            <a:off x="1816608" y="3507801"/>
            <a:ext cx="4047744" cy="3230898"/>
          </a:xfrm>
          <a:prstGeom prst="rect">
            <a:avLst/>
          </a:prstGeom>
        </p:spPr>
      </p:pic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ABD23EBA-005D-1F9D-0E66-974D91283B03}"/>
              </a:ext>
            </a:extLst>
          </p:cNvPr>
          <p:cNvSpPr/>
          <p:nvPr/>
        </p:nvSpPr>
        <p:spPr>
          <a:xfrm rot="21258732">
            <a:off x="2501241" y="4114176"/>
            <a:ext cx="2628000" cy="252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48773CD4-6E75-BF62-900C-D0378AD5F16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35" t="65520" r="26550" b="21136"/>
          <a:stretch/>
        </p:blipFill>
        <p:spPr>
          <a:xfrm>
            <a:off x="1816608" y="4953000"/>
            <a:ext cx="4374096" cy="1616008"/>
          </a:xfrm>
          <a:prstGeom prst="rect">
            <a:avLst/>
          </a:prstGeom>
        </p:spPr>
      </p:pic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DB1DD46B-1957-80D6-A8C6-D74EC1F9AD65}"/>
              </a:ext>
            </a:extLst>
          </p:cNvPr>
          <p:cNvSpPr/>
          <p:nvPr/>
        </p:nvSpPr>
        <p:spPr>
          <a:xfrm>
            <a:off x="2762808" y="5945176"/>
            <a:ext cx="2628000" cy="252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</p:spTree>
    <p:extLst>
      <p:ext uri="{BB962C8B-B14F-4D97-AF65-F5344CB8AC3E}">
        <p14:creationId xmlns:p14="http://schemas.microsoft.com/office/powerpoint/2010/main" val="6526274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5F5A51E-25BE-3805-B13D-2FCFB842CF56}"/>
              </a:ext>
            </a:extLst>
          </p:cNvPr>
          <p:cNvSpPr txBox="1"/>
          <p:nvPr/>
        </p:nvSpPr>
        <p:spPr>
          <a:xfrm>
            <a:off x="0" y="15027"/>
            <a:ext cx="1624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5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3441BCE-AC15-723E-CA34-E954DD8659D5}"/>
              </a:ext>
            </a:extLst>
          </p:cNvPr>
          <p:cNvSpPr txBox="1"/>
          <p:nvPr/>
        </p:nvSpPr>
        <p:spPr>
          <a:xfrm>
            <a:off x="257813" y="1528847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</a:t>
            </a:r>
            <a:r>
              <a:rPr kumimoji="1" lang="en-US" altLang="ja-JP" sz="1600" dirty="0" err="1"/>
              <a:t>aS</a:t>
            </a:r>
            <a:endParaRPr kumimoji="1" lang="en-US" altLang="ja-JP" sz="16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D08D9A8-61E7-D65A-4744-8E93FF8976B1}"/>
              </a:ext>
            </a:extLst>
          </p:cNvPr>
          <p:cNvSpPr txBox="1"/>
          <p:nvPr/>
        </p:nvSpPr>
        <p:spPr>
          <a:xfrm>
            <a:off x="58652" y="3850670"/>
            <a:ext cx="13276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β-tubulin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4F4F8B7-CD2A-37B8-0AB4-EBA78F69E051}"/>
              </a:ext>
            </a:extLst>
          </p:cNvPr>
          <p:cNvSpPr txBox="1"/>
          <p:nvPr/>
        </p:nvSpPr>
        <p:spPr>
          <a:xfrm>
            <a:off x="0" y="384359"/>
            <a:ext cx="3383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A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04F3649-1B81-0933-F276-151C490D6476}"/>
              </a:ext>
            </a:extLst>
          </p:cNvPr>
          <p:cNvSpPr txBox="1"/>
          <p:nvPr/>
        </p:nvSpPr>
        <p:spPr>
          <a:xfrm>
            <a:off x="0" y="5100315"/>
            <a:ext cx="3383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C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CDD168F-61DB-D22F-5164-29C5EB5DCDC7}"/>
              </a:ext>
            </a:extLst>
          </p:cNvPr>
          <p:cNvSpPr txBox="1"/>
          <p:nvPr/>
        </p:nvSpPr>
        <p:spPr>
          <a:xfrm>
            <a:off x="260293" y="6172493"/>
            <a:ext cx="11285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</a:t>
            </a:r>
            <a:r>
              <a:rPr kumimoji="1" lang="en-US" altLang="ja-JP" sz="1600" dirty="0" err="1"/>
              <a:t>aS</a:t>
            </a:r>
            <a:endParaRPr kumimoji="1" lang="en-US" altLang="ja-JP" sz="16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61DEBBF-069C-116D-6927-7B18C927FF1F}"/>
              </a:ext>
            </a:extLst>
          </p:cNvPr>
          <p:cNvSpPr txBox="1"/>
          <p:nvPr/>
        </p:nvSpPr>
        <p:spPr>
          <a:xfrm>
            <a:off x="148353" y="8155762"/>
            <a:ext cx="13276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β-tubulin</a:t>
            </a:r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8EE31E10-6F43-1F95-16FB-C298EA49BDF8}"/>
              </a:ext>
            </a:extLst>
          </p:cNvPr>
          <p:cNvGrpSpPr>
            <a:grpSpLocks noChangeAspect="1"/>
          </p:cNvGrpSpPr>
          <p:nvPr/>
        </p:nvGrpSpPr>
        <p:grpSpPr>
          <a:xfrm>
            <a:off x="1524001" y="617935"/>
            <a:ext cx="2863135" cy="2137458"/>
            <a:chOff x="1524001" y="617934"/>
            <a:chExt cx="4669536" cy="3486017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D2583EC0-51AA-DA79-4F2E-4932D9E286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90" t="59388" r="27661" b="16398"/>
            <a:stretch/>
          </p:blipFill>
          <p:spPr>
            <a:xfrm>
              <a:off x="1524001" y="617934"/>
              <a:ext cx="4669536" cy="3486017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16574DFD-0597-C8E9-531C-4A989FDFC269}"/>
                </a:ext>
              </a:extLst>
            </p:cNvPr>
            <p:cNvSpPr/>
            <p:nvPr/>
          </p:nvSpPr>
          <p:spPr>
            <a:xfrm>
              <a:off x="2285971" y="2655709"/>
              <a:ext cx="1897200" cy="2952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noFill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3A56578A-40DA-BA79-DB87-E36CAA2886B8}"/>
              </a:ext>
            </a:extLst>
          </p:cNvPr>
          <p:cNvGrpSpPr>
            <a:grpSpLocks noChangeAspect="1"/>
          </p:cNvGrpSpPr>
          <p:nvPr/>
        </p:nvGrpSpPr>
        <p:grpSpPr>
          <a:xfrm>
            <a:off x="1624384" y="3185293"/>
            <a:ext cx="2863135" cy="1907088"/>
            <a:chOff x="1620327" y="4233805"/>
            <a:chExt cx="4255008" cy="2834192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18DBC971-18CF-D459-7EFD-885D0E4E7A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580" t="58568" r="32309" b="22258"/>
            <a:stretch/>
          </p:blipFill>
          <p:spPr>
            <a:xfrm>
              <a:off x="1620327" y="4233805"/>
              <a:ext cx="4255008" cy="2834192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178393C2-4262-4D01-7B42-070533421A41}"/>
                </a:ext>
              </a:extLst>
            </p:cNvPr>
            <p:cNvSpPr/>
            <p:nvPr/>
          </p:nvSpPr>
          <p:spPr>
            <a:xfrm>
              <a:off x="2327836" y="5075045"/>
              <a:ext cx="1897200" cy="2952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noFill/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1F29507B-B799-C919-02F6-3615F8ECB788}"/>
              </a:ext>
            </a:extLst>
          </p:cNvPr>
          <p:cNvGrpSpPr>
            <a:grpSpLocks noChangeAspect="1"/>
          </p:cNvGrpSpPr>
          <p:nvPr/>
        </p:nvGrpSpPr>
        <p:grpSpPr>
          <a:xfrm>
            <a:off x="1638525" y="5331148"/>
            <a:ext cx="2748611" cy="1778665"/>
            <a:chOff x="1121664" y="5283226"/>
            <a:chExt cx="4753671" cy="3076168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10074869-56A3-5087-0834-10639BF167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40000" contrast="7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65" t="56699" r="27179" b="20097"/>
            <a:stretch/>
          </p:blipFill>
          <p:spPr>
            <a:xfrm>
              <a:off x="1121664" y="5283226"/>
              <a:ext cx="4753671" cy="3076168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FBDA7139-6AD8-C61E-FCA0-1CC339695A19}"/>
                </a:ext>
              </a:extLst>
            </p:cNvPr>
            <p:cNvSpPr/>
            <p:nvPr/>
          </p:nvSpPr>
          <p:spPr>
            <a:xfrm>
              <a:off x="2339085" y="7333040"/>
              <a:ext cx="2502000" cy="2340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noFill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E2515A43-C63E-AEB9-139D-4C7FACDC42D8}"/>
              </a:ext>
            </a:extLst>
          </p:cNvPr>
          <p:cNvGrpSpPr>
            <a:grpSpLocks noChangeAspect="1"/>
          </p:cNvGrpSpPr>
          <p:nvPr/>
        </p:nvGrpSpPr>
        <p:grpSpPr>
          <a:xfrm>
            <a:off x="1638525" y="7348580"/>
            <a:ext cx="3385300" cy="2354933"/>
            <a:chOff x="4737235" y="4754880"/>
            <a:chExt cx="4784717" cy="3328416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46B147FB-91B0-D8CE-2417-0A10B61F02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45" t="57932" r="24809" b="17829"/>
            <a:stretch/>
          </p:blipFill>
          <p:spPr>
            <a:xfrm>
              <a:off x="4737235" y="4754880"/>
              <a:ext cx="4784717" cy="3328416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4DB7F539-3A48-EF41-777A-22B22EC85AD7}"/>
                </a:ext>
              </a:extLst>
            </p:cNvPr>
            <p:cNvSpPr/>
            <p:nvPr/>
          </p:nvSpPr>
          <p:spPr>
            <a:xfrm>
              <a:off x="5909088" y="5938493"/>
              <a:ext cx="2502000" cy="2340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noFill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012100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6ED0C3F-5DD6-3F6F-359E-031BB20186BD}"/>
              </a:ext>
            </a:extLst>
          </p:cNvPr>
          <p:cNvSpPr txBox="1"/>
          <p:nvPr/>
        </p:nvSpPr>
        <p:spPr>
          <a:xfrm>
            <a:off x="0" y="15027"/>
            <a:ext cx="16243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5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47A26F6-00AD-924F-55C9-477AF0ACE2A3}"/>
              </a:ext>
            </a:extLst>
          </p:cNvPr>
          <p:cNvSpPr txBox="1"/>
          <p:nvPr/>
        </p:nvSpPr>
        <p:spPr>
          <a:xfrm>
            <a:off x="167934" y="1784376"/>
            <a:ext cx="164867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cleaved caspase-3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CF5AD36-6C72-A7DC-D596-CBDF322E236C}"/>
              </a:ext>
            </a:extLst>
          </p:cNvPr>
          <p:cNvSpPr txBox="1"/>
          <p:nvPr/>
        </p:nvSpPr>
        <p:spPr>
          <a:xfrm>
            <a:off x="167934" y="3140851"/>
            <a:ext cx="13276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IB: β-tubulin</a:t>
            </a: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15810D6E-2C45-EB08-685C-86F59501C2C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95" t="63948" r="28260" b="23793"/>
          <a:stretch/>
        </p:blipFill>
        <p:spPr>
          <a:xfrm>
            <a:off x="1516186" y="1330450"/>
            <a:ext cx="4230624" cy="1584959"/>
          </a:xfrm>
          <a:prstGeom prst="rect">
            <a:avLst/>
          </a:prstGeom>
          <a:ln w="19050">
            <a:noFill/>
          </a:ln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495DA80B-7E7E-22D0-7AA6-456815C25B2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90" t="67524" r="28797" b="20776"/>
          <a:stretch/>
        </p:blipFill>
        <p:spPr>
          <a:xfrm>
            <a:off x="1558089" y="3479405"/>
            <a:ext cx="4122426" cy="1473595"/>
          </a:xfrm>
          <a:prstGeom prst="rect">
            <a:avLst/>
          </a:prstGeom>
          <a:ln w="19050">
            <a:noFill/>
          </a:ln>
        </p:spPr>
      </p:pic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9BED6825-79E0-AE16-BE7F-F6A8A39C07A2}"/>
              </a:ext>
            </a:extLst>
          </p:cNvPr>
          <p:cNvSpPr/>
          <p:nvPr/>
        </p:nvSpPr>
        <p:spPr>
          <a:xfrm>
            <a:off x="2429266" y="2203383"/>
            <a:ext cx="2502000" cy="234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40080E9C-9743-515B-DDF2-D5482186D919}"/>
              </a:ext>
            </a:extLst>
          </p:cNvPr>
          <p:cNvSpPr/>
          <p:nvPr/>
        </p:nvSpPr>
        <p:spPr>
          <a:xfrm>
            <a:off x="2314203" y="4214528"/>
            <a:ext cx="2502000" cy="234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noFill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1F12343-CDAC-F413-7FDA-E2AE4C7E8D4D}"/>
              </a:ext>
            </a:extLst>
          </p:cNvPr>
          <p:cNvSpPr txBox="1"/>
          <p:nvPr/>
        </p:nvSpPr>
        <p:spPr>
          <a:xfrm>
            <a:off x="0" y="384359"/>
            <a:ext cx="3383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685873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22</TotalTime>
  <Words>115</Words>
  <Application>Microsoft Office PowerPoint</Application>
  <PresentationFormat>A4 210 x 297 mm</PresentationFormat>
  <Paragraphs>47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da Shun</dc:creator>
  <cp:lastModifiedBy>Shun Yoshida</cp:lastModifiedBy>
  <cp:revision>3</cp:revision>
  <dcterms:created xsi:type="dcterms:W3CDTF">2023-04-26T10:38:58Z</dcterms:created>
  <dcterms:modified xsi:type="dcterms:W3CDTF">2023-12-15T11:18:32Z</dcterms:modified>
</cp:coreProperties>
</file>